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4"/>
  </p:notesMasterIdLst>
  <p:sldIdLst>
    <p:sldId id="306" r:id="rId2"/>
    <p:sldId id="307" r:id="rId3"/>
  </p:sldIdLst>
  <p:sldSz cx="9601200" cy="12801600" type="A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43" roundtripDataSignature="AMtx7mg+hHd+RIbHflYKdspPB018ouFk4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4DDDF"/>
    <a:srgbClr val="C7D4D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85F1885-0034-4247-91EA-1EFC0018557B}" v="19" dt="2026-02-04T08:18:37.58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87" autoAdjust="0"/>
    <p:restoredTop sz="92857" autoAdjust="0"/>
  </p:normalViewPr>
  <p:slideViewPr>
    <p:cSldViewPr snapToGrid="0">
      <p:cViewPr>
        <p:scale>
          <a:sx n="100" d="100"/>
          <a:sy n="100" d="100"/>
        </p:scale>
        <p:origin x="1950" y="-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7" Type="http://schemas.openxmlformats.org/officeDocument/2006/relationships/tableStyles" Target="tableStyles.xml"/><Relationship Id="rId46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45" Type="http://schemas.openxmlformats.org/officeDocument/2006/relationships/viewProps" Target="viewProps.xml"/><Relationship Id="rId49" Type="http://schemas.microsoft.com/office/2015/10/relationships/revisionInfo" Target="revisionInfo.xml"/><Relationship Id="rId44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43" Type="http://customschemas.google.com/relationships/presentationmetadata" Target="metadata"/><Relationship Id="rId48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ong su Choi" userId="e87a116d3ef85571" providerId="LiveId" clId="{62686773-2A74-408D-A8C8-B00B36D5C126}"/>
    <pc:docChg chg="undo custSel addSld modSld">
      <pc:chgData name="Bong su Choi" userId="e87a116d3ef85571" providerId="LiveId" clId="{62686773-2A74-408D-A8C8-B00B36D5C126}" dt="2026-02-04T08:18:43.839" v="524" actId="113"/>
      <pc:docMkLst>
        <pc:docMk/>
      </pc:docMkLst>
      <pc:sldChg chg="addSp delSp modSp mod">
        <pc:chgData name="Bong su Choi" userId="e87a116d3ef85571" providerId="LiveId" clId="{62686773-2A74-408D-A8C8-B00B36D5C126}" dt="2026-02-04T08:18:43.839" v="524" actId="113"/>
        <pc:sldMkLst>
          <pc:docMk/>
          <pc:sldMk cId="420326715" sldId="306"/>
        </pc:sldMkLst>
        <pc:spChg chg="mod">
          <ac:chgData name="Bong su Choi" userId="e87a116d3ef85571" providerId="LiveId" clId="{62686773-2A74-408D-A8C8-B00B36D5C126}" dt="2026-02-04T08:10:29.663" v="217" actId="21"/>
          <ac:spMkLst>
            <pc:docMk/>
            <pc:sldMk cId="420326715" sldId="306"/>
            <ac:spMk id="23" creationId="{53940358-6E5B-9257-B4C5-5305F8552303}"/>
          </ac:spMkLst>
        </pc:spChg>
        <pc:spChg chg="add mod">
          <ac:chgData name="Bong su Choi" userId="e87a116d3ef85571" providerId="LiveId" clId="{62686773-2A74-408D-A8C8-B00B36D5C126}" dt="2026-02-04T08:13:27.214" v="331" actId="1076"/>
          <ac:spMkLst>
            <pc:docMk/>
            <pc:sldMk cId="420326715" sldId="306"/>
            <ac:spMk id="67" creationId="{A94C3B2A-3BF5-B3D6-A9DC-8CF031A2FF67}"/>
          </ac:spMkLst>
        </pc:spChg>
        <pc:spChg chg="add mod">
          <ac:chgData name="Bong su Choi" userId="e87a116d3ef85571" providerId="LiveId" clId="{62686773-2A74-408D-A8C8-B00B36D5C126}" dt="2026-02-04T08:11:54.625" v="256" actId="1076"/>
          <ac:spMkLst>
            <pc:docMk/>
            <pc:sldMk cId="420326715" sldId="306"/>
            <ac:spMk id="69" creationId="{ACFA87BF-F937-7E51-CCB0-FBBAA44403DA}"/>
          </ac:spMkLst>
        </pc:spChg>
        <pc:spChg chg="add mod">
          <ac:chgData name="Bong su Choi" userId="e87a116d3ef85571" providerId="LiveId" clId="{62686773-2A74-408D-A8C8-B00B36D5C126}" dt="2026-02-04T08:11:52.341" v="255" actId="1076"/>
          <ac:spMkLst>
            <pc:docMk/>
            <pc:sldMk cId="420326715" sldId="306"/>
            <ac:spMk id="71" creationId="{E5011E35-8205-7802-456E-AB18E1FB6F7F}"/>
          </ac:spMkLst>
        </pc:spChg>
        <pc:spChg chg="add del mod">
          <ac:chgData name="Bong su Choi" userId="e87a116d3ef85571" providerId="LiveId" clId="{62686773-2A74-408D-A8C8-B00B36D5C126}" dt="2026-02-04T08:14:52.737" v="387" actId="478"/>
          <ac:spMkLst>
            <pc:docMk/>
            <pc:sldMk cId="420326715" sldId="306"/>
            <ac:spMk id="72" creationId="{8DE6FD4C-BBD5-96EC-0CDE-B68785B0372F}"/>
          </ac:spMkLst>
        </pc:spChg>
        <pc:spChg chg="add mod">
          <ac:chgData name="Bong su Choi" userId="e87a116d3ef85571" providerId="LiveId" clId="{62686773-2A74-408D-A8C8-B00B36D5C126}" dt="2026-02-04T08:13:50.586" v="355" actId="20577"/>
          <ac:spMkLst>
            <pc:docMk/>
            <pc:sldMk cId="420326715" sldId="306"/>
            <ac:spMk id="74" creationId="{61BD2122-5885-5481-E91B-5221FA36C14A}"/>
          </ac:spMkLst>
        </pc:spChg>
        <pc:spChg chg="add mod">
          <ac:chgData name="Bong su Choi" userId="e87a116d3ef85571" providerId="LiveId" clId="{62686773-2A74-408D-A8C8-B00B36D5C126}" dt="2026-02-04T08:18:43.839" v="524" actId="113"/>
          <ac:spMkLst>
            <pc:docMk/>
            <pc:sldMk cId="420326715" sldId="306"/>
            <ac:spMk id="75" creationId="{7FE65BA6-50D7-5FF6-9133-2A0610A8E588}"/>
          </ac:spMkLst>
        </pc:spChg>
        <pc:picChg chg="add mod">
          <ac:chgData name="Bong su Choi" userId="e87a116d3ef85571" providerId="LiveId" clId="{62686773-2A74-408D-A8C8-B00B36D5C126}" dt="2026-02-04T08:13:27.214" v="331" actId="1076"/>
          <ac:picMkLst>
            <pc:docMk/>
            <pc:sldMk cId="420326715" sldId="306"/>
            <ac:picMk id="55" creationId="{8D8706CE-CB0E-EB1D-A0F0-37BD7CC37FA4}"/>
          </ac:picMkLst>
        </pc:picChg>
        <pc:picChg chg="add mod">
          <ac:chgData name="Bong su Choi" userId="e87a116d3ef85571" providerId="LiveId" clId="{62686773-2A74-408D-A8C8-B00B36D5C126}" dt="2026-02-04T08:11:38.247" v="252" actId="1076"/>
          <ac:picMkLst>
            <pc:docMk/>
            <pc:sldMk cId="420326715" sldId="306"/>
            <ac:picMk id="61" creationId="{CB71FAFE-96F9-50B4-EF53-C4BEC8451C16}"/>
          </ac:picMkLst>
        </pc:picChg>
        <pc:picChg chg="add del mod">
          <ac:chgData name="Bong su Choi" userId="e87a116d3ef85571" providerId="LiveId" clId="{62686773-2A74-408D-A8C8-B00B36D5C126}" dt="2026-02-04T08:09:59.181" v="201" actId="21"/>
          <ac:picMkLst>
            <pc:docMk/>
            <pc:sldMk cId="420326715" sldId="306"/>
            <ac:picMk id="63" creationId="{936C14C0-6DEE-20A1-DB57-7FCACAD0DE38}"/>
          </ac:picMkLst>
        </pc:picChg>
        <pc:picChg chg="add del mod">
          <ac:chgData name="Bong su Choi" userId="e87a116d3ef85571" providerId="LiveId" clId="{62686773-2A74-408D-A8C8-B00B36D5C126}" dt="2026-02-04T08:09:59.181" v="201" actId="21"/>
          <ac:picMkLst>
            <pc:docMk/>
            <pc:sldMk cId="420326715" sldId="306"/>
            <ac:picMk id="66" creationId="{6D0B5F1D-19EA-5D45-AFCF-3E4D6AC905D2}"/>
          </ac:picMkLst>
        </pc:picChg>
        <pc:picChg chg="add mod">
          <ac:chgData name="Bong su Choi" userId="e87a116d3ef85571" providerId="LiveId" clId="{62686773-2A74-408D-A8C8-B00B36D5C126}" dt="2026-02-04T08:11:47.401" v="254" actId="14100"/>
          <ac:picMkLst>
            <pc:docMk/>
            <pc:sldMk cId="420326715" sldId="306"/>
            <ac:picMk id="70" creationId="{60FB02CA-961E-F777-DDA2-3550F93C2010}"/>
          </ac:picMkLst>
        </pc:picChg>
        <pc:picChg chg="add mod">
          <ac:chgData name="Bong su Choi" userId="e87a116d3ef85571" providerId="LiveId" clId="{62686773-2A74-408D-A8C8-B00B36D5C126}" dt="2026-02-04T08:13:35.793" v="334" actId="1076"/>
          <ac:picMkLst>
            <pc:docMk/>
            <pc:sldMk cId="420326715" sldId="306"/>
            <ac:picMk id="73" creationId="{A8A4A0B0-D5AC-18C0-638B-A1486F9CF761}"/>
          </ac:picMkLst>
        </pc:picChg>
      </pc:sldChg>
      <pc:sldChg chg="addSp delSp modSp new mod">
        <pc:chgData name="Bong su Choi" userId="e87a116d3ef85571" providerId="LiveId" clId="{62686773-2A74-408D-A8C8-B00B36D5C126}" dt="2026-02-04T08:18:41.729" v="523" actId="1076"/>
        <pc:sldMkLst>
          <pc:docMk/>
          <pc:sldMk cId="378239200" sldId="307"/>
        </pc:sldMkLst>
        <pc:spChg chg="del">
          <ac:chgData name="Bong su Choi" userId="e87a116d3ef85571" providerId="LiveId" clId="{62686773-2A74-408D-A8C8-B00B36D5C126}" dt="2026-02-04T08:06:04.530" v="13" actId="478"/>
          <ac:spMkLst>
            <pc:docMk/>
            <pc:sldMk cId="378239200" sldId="307"/>
            <ac:spMk id="2" creationId="{3940C790-F6D7-D29C-CD5B-E5EA7FCAF25E}"/>
          </ac:spMkLst>
        </pc:spChg>
        <pc:spChg chg="del">
          <ac:chgData name="Bong su Choi" userId="e87a116d3ef85571" providerId="LiveId" clId="{62686773-2A74-408D-A8C8-B00B36D5C126}" dt="2026-02-04T08:06:05.561" v="14" actId="478"/>
          <ac:spMkLst>
            <pc:docMk/>
            <pc:sldMk cId="378239200" sldId="307"/>
            <ac:spMk id="3" creationId="{D9AD6148-0DE3-F02B-D700-A0D52CA5C7D5}"/>
          </ac:spMkLst>
        </pc:spChg>
        <pc:spChg chg="add mod">
          <ac:chgData name="Bong su Choi" userId="e87a116d3ef85571" providerId="LiveId" clId="{62686773-2A74-408D-A8C8-B00B36D5C126}" dt="2026-02-04T08:18:41.729" v="523" actId="1076"/>
          <ac:spMkLst>
            <pc:docMk/>
            <pc:sldMk cId="378239200" sldId="307"/>
            <ac:spMk id="8" creationId="{127CEA5B-6CB6-2035-9BE5-BE79DD782AA7}"/>
          </ac:spMkLst>
        </pc:spChg>
        <pc:spChg chg="add mod">
          <ac:chgData name="Bong su Choi" userId="e87a116d3ef85571" providerId="LiveId" clId="{62686773-2A74-408D-A8C8-B00B36D5C126}" dt="2026-02-04T08:17:56.654" v="504" actId="1076"/>
          <ac:spMkLst>
            <pc:docMk/>
            <pc:sldMk cId="378239200" sldId="307"/>
            <ac:spMk id="9" creationId="{71D5C738-593B-BB6B-DE92-ACD81999EE09}"/>
          </ac:spMkLst>
        </pc:spChg>
        <pc:spChg chg="add mod">
          <ac:chgData name="Bong su Choi" userId="e87a116d3ef85571" providerId="LiveId" clId="{62686773-2A74-408D-A8C8-B00B36D5C126}" dt="2026-02-04T08:17:45.126" v="500" actId="1076"/>
          <ac:spMkLst>
            <pc:docMk/>
            <pc:sldMk cId="378239200" sldId="307"/>
            <ac:spMk id="11" creationId="{19D29DCE-F803-CF45-2B55-E72438A00F8B}"/>
          </ac:spMkLst>
        </pc:spChg>
        <pc:spChg chg="add mod">
          <ac:chgData name="Bong su Choi" userId="e87a116d3ef85571" providerId="LiveId" clId="{62686773-2A74-408D-A8C8-B00B36D5C126}" dt="2026-02-04T08:17:48.414" v="501" actId="1076"/>
          <ac:spMkLst>
            <pc:docMk/>
            <pc:sldMk cId="378239200" sldId="307"/>
            <ac:spMk id="12" creationId="{BB8153AA-CC85-9EAF-5483-26DE650C0A0F}"/>
          </ac:spMkLst>
        </pc:spChg>
        <pc:spChg chg="add mod">
          <ac:chgData name="Bong su Choi" userId="e87a116d3ef85571" providerId="LiveId" clId="{62686773-2A74-408D-A8C8-B00B36D5C126}" dt="2026-02-04T08:18:05.423" v="517" actId="20577"/>
          <ac:spMkLst>
            <pc:docMk/>
            <pc:sldMk cId="378239200" sldId="307"/>
            <ac:spMk id="15" creationId="{32BAB5FE-5552-CFF5-3894-A06FF1730F59}"/>
          </ac:spMkLst>
        </pc:spChg>
        <pc:spChg chg="add mod">
          <ac:chgData name="Bong su Choi" userId="e87a116d3ef85571" providerId="LiveId" clId="{62686773-2A74-408D-A8C8-B00B36D5C126}" dt="2026-02-04T08:18:11.203" v="519" actId="1037"/>
          <ac:spMkLst>
            <pc:docMk/>
            <pc:sldMk cId="378239200" sldId="307"/>
            <ac:spMk id="16" creationId="{88B1BC78-A3D7-B349-9BA8-5CAB2FE83A35}"/>
          </ac:spMkLst>
        </pc:spChg>
        <pc:picChg chg="add del mod">
          <ac:chgData name="Bong su Choi" userId="e87a116d3ef85571" providerId="LiveId" clId="{62686773-2A74-408D-A8C8-B00B36D5C126}" dt="2026-02-04T08:16:16.699" v="457" actId="478"/>
          <ac:picMkLst>
            <pc:docMk/>
            <pc:sldMk cId="378239200" sldId="307"/>
            <ac:picMk id="5" creationId="{E8B28536-6BB1-C358-7508-6C6CA9FEAA53}"/>
          </ac:picMkLst>
        </pc:picChg>
        <pc:picChg chg="add del mod">
          <ac:chgData name="Bong su Choi" userId="e87a116d3ef85571" providerId="LiveId" clId="{62686773-2A74-408D-A8C8-B00B36D5C126}" dt="2026-02-04T08:09:49.638" v="197" actId="21"/>
          <ac:picMkLst>
            <pc:docMk/>
            <pc:sldMk cId="378239200" sldId="307"/>
            <ac:picMk id="7" creationId="{60FB02CA-961E-F777-DDA2-3550F93C2010}"/>
          </ac:picMkLst>
        </pc:picChg>
        <pc:picChg chg="add mod">
          <ac:chgData name="Bong su Choi" userId="e87a116d3ef85571" providerId="LiveId" clId="{62686773-2A74-408D-A8C8-B00B36D5C126}" dt="2026-02-04T08:16:18.449" v="458"/>
          <ac:picMkLst>
            <pc:docMk/>
            <pc:sldMk cId="378239200" sldId="307"/>
            <ac:picMk id="10" creationId="{E0C7AB20-D878-5F74-74D0-B9C2F615CC57}"/>
          </ac:picMkLst>
        </pc:picChg>
        <pc:picChg chg="add mod">
          <ac:chgData name="Bong su Choi" userId="e87a116d3ef85571" providerId="LiveId" clId="{62686773-2A74-408D-A8C8-B00B36D5C126}" dt="2026-02-04T08:17:14.612" v="485"/>
          <ac:picMkLst>
            <pc:docMk/>
            <pc:sldMk cId="378239200" sldId="307"/>
            <ac:picMk id="13" creationId="{008426EF-1BD2-86CC-D5DA-3B9BC0F12978}"/>
          </ac:picMkLst>
        </pc:picChg>
        <pc:picChg chg="add mod">
          <ac:chgData name="Bong su Choi" userId="e87a116d3ef85571" providerId="LiveId" clId="{62686773-2A74-408D-A8C8-B00B36D5C126}" dt="2026-02-04T08:17:31.951" v="497" actId="14100"/>
          <ac:picMkLst>
            <pc:docMk/>
            <pc:sldMk cId="378239200" sldId="307"/>
            <ac:picMk id="63" creationId="{936C14C0-6DEE-20A1-DB57-7FCACAD0DE38}"/>
          </ac:picMkLst>
        </pc:picChg>
        <pc:picChg chg="add del mod">
          <ac:chgData name="Bong su Choi" userId="e87a116d3ef85571" providerId="LiveId" clId="{62686773-2A74-408D-A8C8-B00B36D5C126}" dt="2026-02-04T08:17:17.457" v="486" actId="478"/>
          <ac:picMkLst>
            <pc:docMk/>
            <pc:sldMk cId="378239200" sldId="307"/>
            <ac:picMk id="66" creationId="{6D0B5F1D-19EA-5D45-AFCF-3E4D6AC905D2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빈 화면" type="blank">
  <p:cSld name="BLANK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9"/>
          <p:cNvSpPr txBox="1">
            <a:spLocks noGrp="1"/>
          </p:cNvSpPr>
          <p:nvPr>
            <p:ph type="dt" idx="10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9"/>
          <p:cNvSpPr txBox="1">
            <a:spLocks noGrp="1"/>
          </p:cNvSpPr>
          <p:nvPr>
            <p:ph type="ftr" idx="11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9"/>
          <p:cNvSpPr txBox="1">
            <a:spLocks noGrp="1"/>
          </p:cNvSpPr>
          <p:nvPr>
            <p:ph type="sldNum" idx="12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제목 및 세로 텍스트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7"/>
          <p:cNvSpPr txBox="1"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7"/>
          <p:cNvSpPr txBox="1">
            <a:spLocks noGrp="1"/>
          </p:cNvSpPr>
          <p:nvPr>
            <p:ph type="body" idx="1"/>
          </p:nvPr>
        </p:nvSpPr>
        <p:spPr>
          <a:xfrm rot="5400000">
            <a:off x="739352" y="3328565"/>
            <a:ext cx="8122498" cy="82810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7"/>
          <p:cNvSpPr txBox="1">
            <a:spLocks noGrp="1"/>
          </p:cNvSpPr>
          <p:nvPr>
            <p:ph type="dt" idx="10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7"/>
          <p:cNvSpPr txBox="1">
            <a:spLocks noGrp="1"/>
          </p:cNvSpPr>
          <p:nvPr>
            <p:ph type="ftr" idx="11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7"/>
          <p:cNvSpPr txBox="1">
            <a:spLocks noGrp="1"/>
          </p:cNvSpPr>
          <p:nvPr>
            <p:ph type="sldNum" idx="12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세로 제목 및 텍스트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8"/>
          <p:cNvSpPr txBox="1">
            <a:spLocks noGrp="1"/>
          </p:cNvSpPr>
          <p:nvPr>
            <p:ph type="title"/>
          </p:nvPr>
        </p:nvSpPr>
        <p:spPr>
          <a:xfrm rot="5400000">
            <a:off x="2481606" y="5070820"/>
            <a:ext cx="10848764" cy="20702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8"/>
          <p:cNvSpPr txBox="1">
            <a:spLocks noGrp="1"/>
          </p:cNvSpPr>
          <p:nvPr>
            <p:ph type="body" idx="1"/>
          </p:nvPr>
        </p:nvSpPr>
        <p:spPr>
          <a:xfrm rot="5400000">
            <a:off x="-1718919" y="3060568"/>
            <a:ext cx="10848764" cy="60907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8"/>
          <p:cNvSpPr txBox="1">
            <a:spLocks noGrp="1"/>
          </p:cNvSpPr>
          <p:nvPr>
            <p:ph type="dt" idx="10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8"/>
          <p:cNvSpPr txBox="1">
            <a:spLocks noGrp="1"/>
          </p:cNvSpPr>
          <p:nvPr>
            <p:ph type="ftr" idx="11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8"/>
          <p:cNvSpPr txBox="1">
            <a:spLocks noGrp="1"/>
          </p:cNvSpPr>
          <p:nvPr>
            <p:ph type="sldNum" idx="12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EFAUL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302283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7"/>
          <p:cNvSpPr txBox="1"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620"/>
              <a:buFont typeface="Calibri"/>
              <a:buNone/>
              <a:defRPr sz="46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7"/>
          <p:cNvSpPr txBox="1"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15290" algn="l" rtl="0">
              <a:lnSpc>
                <a:spcPct val="90000"/>
              </a:lnSpc>
              <a:spcBef>
                <a:spcPts val="1050"/>
              </a:spcBef>
              <a:spcAft>
                <a:spcPts val="0"/>
              </a:spcAft>
              <a:buClr>
                <a:schemeClr val="dk1"/>
              </a:buClr>
              <a:buSzPts val="2940"/>
              <a:buFont typeface="Arial"/>
              <a:buChar char="•"/>
              <a:defRPr sz="29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8619" algn="l" rtl="0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2520"/>
              <a:buFont typeface="Arial"/>
              <a:buChar char="•"/>
              <a:defRPr sz="25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61950" algn="l" rtl="0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8614" algn="l" rtl="0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90"/>
              <a:buFont typeface="Arial"/>
              <a:buChar char="•"/>
              <a:defRPr sz="189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8614" algn="l" rtl="0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90"/>
              <a:buFont typeface="Arial"/>
              <a:buChar char="•"/>
              <a:defRPr sz="189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8614" algn="l" rtl="0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90"/>
              <a:buFont typeface="Arial"/>
              <a:buChar char="•"/>
              <a:defRPr sz="189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8614" algn="l" rtl="0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90"/>
              <a:buFont typeface="Arial"/>
              <a:buChar char="•"/>
              <a:defRPr sz="189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8615" algn="l" rtl="0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90"/>
              <a:buFont typeface="Arial"/>
              <a:buChar char="•"/>
              <a:defRPr sz="189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8615" algn="l" rtl="0">
              <a:lnSpc>
                <a:spcPct val="90000"/>
              </a:lnSpc>
              <a:spcBef>
                <a:spcPts val="525"/>
              </a:spcBef>
              <a:spcAft>
                <a:spcPts val="0"/>
              </a:spcAft>
              <a:buClr>
                <a:schemeClr val="dk1"/>
              </a:buClr>
              <a:buSzPts val="1890"/>
              <a:buFont typeface="Arial"/>
              <a:buChar char="•"/>
              <a:defRPr sz="189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7"/>
          <p:cNvSpPr txBox="1">
            <a:spLocks noGrp="1"/>
          </p:cNvSpPr>
          <p:nvPr>
            <p:ph type="dt" idx="10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7"/>
          <p:cNvSpPr txBox="1">
            <a:spLocks noGrp="1"/>
          </p:cNvSpPr>
          <p:nvPr>
            <p:ph type="ftr" idx="11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7"/>
          <p:cNvSpPr txBox="1">
            <a:spLocks noGrp="1"/>
          </p:cNvSpPr>
          <p:nvPr>
            <p:ph type="sldNum" idx="12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8" r:id="rId2"/>
    <p:sldLayoutId id="2147483659" r:id="rId3"/>
    <p:sldLayoutId id="2147483660" r:id="rId4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A9122DB-93E9-DC3E-EC0E-D7BD643463F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>
            <a:extLst>
              <a:ext uri="{FF2B5EF4-FFF2-40B4-BE49-F238E27FC236}">
                <a16:creationId xmlns:a16="http://schemas.microsoft.com/office/drawing/2014/main" id="{53940358-6E5B-9257-B4C5-5305F8552303}"/>
              </a:ext>
            </a:extLst>
          </p:cNvPr>
          <p:cNvSpPr txBox="1"/>
          <p:nvPr/>
        </p:nvSpPr>
        <p:spPr>
          <a:xfrm>
            <a:off x="350291" y="216729"/>
            <a:ext cx="87177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material. Destination vectors used in this study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8D8706CE-CB0E-EB1D-A0F0-37BD7CC37F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77271" y="712168"/>
            <a:ext cx="3572793" cy="5050594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CB71FAFE-96F9-50B4-EF53-C4BEC8451C1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4114" y="5319315"/>
            <a:ext cx="3972843" cy="3439047"/>
          </a:xfrm>
          <a:prstGeom prst="rect">
            <a:avLst/>
          </a:prstGeom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A94C3B2A-3BF5-B3D6-A9DC-8CF031A2FF67}"/>
              </a:ext>
            </a:extLst>
          </p:cNvPr>
          <p:cNvSpPr txBox="1"/>
          <p:nvPr/>
        </p:nvSpPr>
        <p:spPr>
          <a:xfrm>
            <a:off x="5047332" y="912113"/>
            <a:ext cx="2114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Reporter </a:t>
            </a:r>
            <a:r>
              <a:rPr lang="en-US" altLang="ko-KR" i="1" dirty="0"/>
              <a:t>SAG12pro:LUC</a:t>
            </a:r>
            <a:endParaRPr lang="ko-KR" altLang="en-US" i="1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ACFA87BF-F937-7E51-CCB0-FBBAA44403DA}"/>
              </a:ext>
            </a:extLst>
          </p:cNvPr>
          <p:cNvSpPr txBox="1"/>
          <p:nvPr/>
        </p:nvSpPr>
        <p:spPr>
          <a:xfrm>
            <a:off x="644171" y="4765351"/>
            <a:ext cx="2114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Effector</a:t>
            </a:r>
            <a:br>
              <a:rPr lang="en-US" altLang="ko-KR" dirty="0"/>
            </a:br>
            <a:r>
              <a:rPr lang="en-US" altLang="ko-KR" i="1" dirty="0"/>
              <a:t>35Sp::HA-GI</a:t>
            </a:r>
            <a:endParaRPr lang="ko-KR" altLang="en-US" i="1" dirty="0"/>
          </a:p>
        </p:txBody>
      </p:sp>
      <p:pic>
        <p:nvPicPr>
          <p:cNvPr id="70" name="Picture 69">
            <a:extLst>
              <a:ext uri="{FF2B5EF4-FFF2-40B4-BE49-F238E27FC236}">
                <a16:creationId xmlns:a16="http://schemas.microsoft.com/office/drawing/2014/main" id="{60FB02CA-961E-F777-DDA2-3550F93C201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00601" y="5210056"/>
            <a:ext cx="4175032" cy="3548306"/>
          </a:xfrm>
          <a:prstGeom prst="rect">
            <a:avLst/>
          </a:prstGeom>
        </p:spPr>
      </p:pic>
      <p:sp>
        <p:nvSpPr>
          <p:cNvPr id="71" name="TextBox 70">
            <a:extLst>
              <a:ext uri="{FF2B5EF4-FFF2-40B4-BE49-F238E27FC236}">
                <a16:creationId xmlns:a16="http://schemas.microsoft.com/office/drawing/2014/main" id="{E5011E35-8205-7802-456E-AB18E1FB6F7F}"/>
              </a:ext>
            </a:extLst>
          </p:cNvPr>
          <p:cNvSpPr txBox="1"/>
          <p:nvPr/>
        </p:nvSpPr>
        <p:spPr>
          <a:xfrm>
            <a:off x="5164243" y="4765351"/>
            <a:ext cx="2114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Effector</a:t>
            </a:r>
            <a:br>
              <a:rPr lang="en-US" altLang="ko-KR" dirty="0"/>
            </a:br>
            <a:r>
              <a:rPr lang="en-US" altLang="ko-KR" i="1" dirty="0"/>
              <a:t>35Sp::WRKY75-HA</a:t>
            </a:r>
            <a:endParaRPr lang="ko-KR" altLang="en-US" i="1" dirty="0"/>
          </a:p>
        </p:txBody>
      </p:sp>
      <p:pic>
        <p:nvPicPr>
          <p:cNvPr id="73" name="Picture 72">
            <a:extLst>
              <a:ext uri="{FF2B5EF4-FFF2-40B4-BE49-F238E27FC236}">
                <a16:creationId xmlns:a16="http://schemas.microsoft.com/office/drawing/2014/main" id="{A8A4A0B0-D5AC-18C0-638B-A1486F9CF76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4114" y="1435333"/>
            <a:ext cx="3972843" cy="3089989"/>
          </a:xfrm>
          <a:prstGeom prst="rect">
            <a:avLst/>
          </a:prstGeom>
        </p:spPr>
      </p:pic>
      <p:sp>
        <p:nvSpPr>
          <p:cNvPr id="74" name="TextBox 73">
            <a:extLst>
              <a:ext uri="{FF2B5EF4-FFF2-40B4-BE49-F238E27FC236}">
                <a16:creationId xmlns:a16="http://schemas.microsoft.com/office/drawing/2014/main" id="{61BD2122-5885-5481-E91B-5221FA36C14A}"/>
              </a:ext>
            </a:extLst>
          </p:cNvPr>
          <p:cNvSpPr txBox="1"/>
          <p:nvPr/>
        </p:nvSpPr>
        <p:spPr>
          <a:xfrm>
            <a:off x="644171" y="933694"/>
            <a:ext cx="2114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Entry vector</a:t>
            </a:r>
          </a:p>
          <a:p>
            <a:r>
              <a:rPr lang="en-US" altLang="ko-KR" i="1" dirty="0" err="1"/>
              <a:t>pTOPO_D</a:t>
            </a:r>
            <a:endParaRPr lang="ko-KR" altLang="en-US" i="1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FE65BA6-50D7-5FF6-9133-2A0610A8E588}"/>
              </a:ext>
            </a:extLst>
          </p:cNvPr>
          <p:cNvSpPr txBox="1"/>
          <p:nvPr/>
        </p:nvSpPr>
        <p:spPr>
          <a:xfrm>
            <a:off x="350291" y="576915"/>
            <a:ext cx="31249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Constructs for Luciferase assay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4203267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62">
            <a:extLst>
              <a:ext uri="{FF2B5EF4-FFF2-40B4-BE49-F238E27FC236}">
                <a16:creationId xmlns:a16="http://schemas.microsoft.com/office/drawing/2014/main" id="{936C14C0-6DEE-20A1-DB57-7FCACAD0DE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11845" y="5319315"/>
            <a:ext cx="4136632" cy="343904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27CEA5B-6CB6-2035-9BE5-BE79DD782AA7}"/>
              </a:ext>
            </a:extLst>
          </p:cNvPr>
          <p:cNvSpPr txBox="1"/>
          <p:nvPr/>
        </p:nvSpPr>
        <p:spPr>
          <a:xfrm>
            <a:off x="350291" y="576915"/>
            <a:ext cx="31249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/>
              <a:t>Constructs for Co-IP</a:t>
            </a:r>
            <a:endParaRPr lang="ko-KR" altLang="en-US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1D5C738-593B-BB6B-DE92-ACD81999EE09}"/>
              </a:ext>
            </a:extLst>
          </p:cNvPr>
          <p:cNvSpPr txBox="1"/>
          <p:nvPr/>
        </p:nvSpPr>
        <p:spPr>
          <a:xfrm>
            <a:off x="548921" y="933694"/>
            <a:ext cx="2114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Entry vector</a:t>
            </a:r>
          </a:p>
          <a:p>
            <a:r>
              <a:rPr lang="en-US" altLang="ko-KR" i="1" dirty="0" err="1"/>
              <a:t>pTOPO_D</a:t>
            </a:r>
            <a:endParaRPr lang="ko-KR" altLang="en-US" i="1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E0C7AB20-D878-5F74-74D0-B9C2F615CC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4114" y="1435333"/>
            <a:ext cx="3972843" cy="3089989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9D29DCE-F803-CF45-2B55-E72438A00F8B}"/>
              </a:ext>
            </a:extLst>
          </p:cNvPr>
          <p:cNvSpPr txBox="1"/>
          <p:nvPr/>
        </p:nvSpPr>
        <p:spPr>
          <a:xfrm>
            <a:off x="644171" y="4955130"/>
            <a:ext cx="21145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i="1" dirty="0"/>
              <a:t>35Sp::HA-GI</a:t>
            </a:r>
            <a:endParaRPr lang="ko-KR" altLang="en-US" i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B8153AA-CC85-9EAF-5483-26DE650C0A0F}"/>
              </a:ext>
            </a:extLst>
          </p:cNvPr>
          <p:cNvSpPr txBox="1"/>
          <p:nvPr/>
        </p:nvSpPr>
        <p:spPr>
          <a:xfrm>
            <a:off x="5145195" y="4919239"/>
            <a:ext cx="31556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i="1" dirty="0"/>
              <a:t>35Sp::GFP-WRKY45 and 75</a:t>
            </a:r>
            <a:endParaRPr lang="ko-KR" altLang="en-US" i="1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008426EF-1BD2-86CC-D5DA-3B9BC0F1297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4114" y="5319315"/>
            <a:ext cx="3972843" cy="3439047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32BAB5FE-5552-CFF5-3894-A06FF1730F59}"/>
              </a:ext>
            </a:extLst>
          </p:cNvPr>
          <p:cNvSpPr txBox="1"/>
          <p:nvPr/>
        </p:nvSpPr>
        <p:spPr>
          <a:xfrm>
            <a:off x="644171" y="4719201"/>
            <a:ext cx="48006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dirty="0"/>
              <a:t>Destination vecto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8B1BC78-A3D7-B349-9BA8-5CAB2FE83A35}"/>
              </a:ext>
            </a:extLst>
          </p:cNvPr>
          <p:cNvSpPr txBox="1"/>
          <p:nvPr/>
        </p:nvSpPr>
        <p:spPr>
          <a:xfrm>
            <a:off x="5157330" y="4719201"/>
            <a:ext cx="48006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dirty="0"/>
              <a:t>Destination vector</a:t>
            </a:r>
          </a:p>
        </p:txBody>
      </p:sp>
    </p:spTree>
    <p:extLst>
      <p:ext uri="{BB962C8B-B14F-4D97-AF65-F5344CB8AC3E}">
        <p14:creationId xmlns:p14="http://schemas.microsoft.com/office/powerpoint/2010/main" val="378239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4484485D-7B14-4E54-9EDB-2C07E1204B98}">
  <we:reference id="wa200006038" version="1.0.0.5" store="en-US" storeType="OMEX"/>
  <we:alternateReferences>
    <we:reference id="wa200006038" version="1.0.0.5" store="" storeType="OMEX"/>
  </we:alternateReferences>
  <we:properties>
    <we:property name="pptx_export_from_biorender" value="false"/>
  </we:properties>
  <we:bindings/>
  <we:snapshot xmlns:r="http://schemas.openxmlformats.org/officeDocument/2006/relationships"/>
  <we:extLst>
    <a:ext xmlns:a="http://schemas.openxmlformats.org/drawingml/2006/main" uri="{0858819E-0033-43BF-8937-05EC82904868}">
      <we:backgroundApp state="1" runtimeId="Taskpane.Url"/>
    </a:ext>
  </we:extLst>
</we:webextension>
</file>

<file path=docProps/app.xml><?xml version="1.0" encoding="utf-8"?>
<Properties xmlns="http://schemas.openxmlformats.org/officeDocument/2006/extended-properties" xmlns:vt="http://schemas.openxmlformats.org/officeDocument/2006/docPropsVTypes">
  <TotalTime>75986</TotalTime>
  <Words>52</Words>
  <Application>Microsoft Office PowerPoint</Application>
  <PresentationFormat>A3 Paper (297x420 mm)</PresentationFormat>
  <Paragraphs>1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테마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정송이</dc:creator>
  <cp:lastModifiedBy>Bong su Choi</cp:lastModifiedBy>
  <cp:revision>74</cp:revision>
  <dcterms:created xsi:type="dcterms:W3CDTF">2025-03-11T03:57:03Z</dcterms:created>
  <dcterms:modified xsi:type="dcterms:W3CDTF">2026-02-04T08:18:45Z</dcterms:modified>
</cp:coreProperties>
</file>